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5" r:id="rId2"/>
  </p:sldIdLst>
  <p:sldSz cx="9144000" cy="6858000" type="screen4x3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  <a:srgbClr val="FF99FF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779" autoAdjust="0"/>
  </p:normalViewPr>
  <p:slideViewPr>
    <p:cSldViewPr>
      <p:cViewPr>
        <p:scale>
          <a:sx n="100" d="100"/>
          <a:sy n="100" d="100"/>
        </p:scale>
        <p:origin x="-1956" y="-6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777609" y="0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53885E-6A45-4EB2-A4B9-EEF79315386F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2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777609" y="9428583"/>
            <a:ext cx="2889938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72C4DF-B057-433F-BB1C-A02C358872E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28946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3D2059-594C-4657-B9EA-AE0CD79C80E5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854075" y="744538"/>
            <a:ext cx="4960938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14875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8250" y="9428163"/>
            <a:ext cx="288925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9DC5A1-8AC7-4DE3-9DAC-1D4AEE41A9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6502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242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675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0966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263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6688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214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082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578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228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510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721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C4717-ABA5-487A-99C4-39629ECA1BE6}" type="datetimeFigureOut">
              <a:rPr lang="en-US" smtClean="0"/>
              <a:t>9/19/2018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216BAD-7E84-43FB-8D5C-E960207A2AF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4874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tiff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uppieren 39"/>
          <p:cNvGrpSpPr/>
          <p:nvPr/>
        </p:nvGrpSpPr>
        <p:grpSpPr>
          <a:xfrm>
            <a:off x="1600200" y="1295400"/>
            <a:ext cx="6634433" cy="3257547"/>
            <a:chOff x="1600200" y="1295400"/>
            <a:chExt cx="6634433" cy="3257547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746" b="9717"/>
            <a:stretch/>
          </p:blipFill>
          <p:spPr bwMode="auto">
            <a:xfrm>
              <a:off x="2481852" y="3575264"/>
              <a:ext cx="3719278" cy="48238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481048" y="3043511"/>
              <a:ext cx="3709853" cy="52555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3" name="Picture 14" descr="C:\Users\Forschung\Desktop\p38.g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5" t="21516" r="40450" b="17334"/>
            <a:stretch/>
          </p:blipFill>
          <p:spPr bwMode="auto">
            <a:xfrm>
              <a:off x="2487784" y="2582952"/>
              <a:ext cx="3705765" cy="4763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9" descr="G:\PAPER antioxidants\pNRF2 30sec2x2,4-4. scan-1.tif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22897" r="42384" b="18431"/>
            <a:stretch/>
          </p:blipFill>
          <p:spPr bwMode="auto">
            <a:xfrm>
              <a:off x="2491586" y="2104520"/>
              <a:ext cx="3713324" cy="4722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" name="Picture 14" descr="C:\Users\Forschung\Desktop\p38.gi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45" t="21516" r="40450" b="17334"/>
            <a:stretch/>
          </p:blipFill>
          <p:spPr bwMode="auto">
            <a:xfrm>
              <a:off x="2491585" y="2595720"/>
              <a:ext cx="3705765" cy="4763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Textfeld 2"/>
            <p:cNvSpPr txBox="1"/>
            <p:nvPr/>
          </p:nvSpPr>
          <p:spPr>
            <a:xfrm>
              <a:off x="2593142" y="1796741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l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feld 3"/>
            <p:cNvSpPr txBox="1"/>
            <p:nvPr/>
          </p:nvSpPr>
          <p:spPr>
            <a:xfrm>
              <a:off x="3242314" y="1796743"/>
              <a:ext cx="564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4450017" y="1584276"/>
              <a:ext cx="662361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/o</a:t>
              </a:r>
            </a:p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ox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3806892" y="1799719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5071114" y="1796742"/>
              <a:ext cx="5645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5561785" y="1786622"/>
              <a:ext cx="6431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sc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Picture 10" descr="C:\Users\Forschung\Desktop\GAPDH.gif"/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95" t="22857" r="42131" b="12857"/>
            <a:stretch/>
          </p:blipFill>
          <p:spPr bwMode="auto">
            <a:xfrm>
              <a:off x="2478073" y="4057648"/>
              <a:ext cx="3726836" cy="48827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Rechteck 10"/>
            <p:cNvSpPr/>
            <p:nvPr/>
          </p:nvSpPr>
          <p:spPr>
            <a:xfrm>
              <a:off x="2478073" y="2104520"/>
              <a:ext cx="3726837" cy="47226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hteck 11"/>
            <p:cNvSpPr/>
            <p:nvPr/>
          </p:nvSpPr>
          <p:spPr>
            <a:xfrm>
              <a:off x="2478072" y="2576784"/>
              <a:ext cx="3726837" cy="4952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3" name="Gerade Verbindung 12"/>
            <p:cNvCxnSpPr/>
            <p:nvPr/>
          </p:nvCxnSpPr>
          <p:spPr>
            <a:xfrm>
              <a:off x="4450017" y="1601689"/>
              <a:ext cx="168789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feld 13"/>
            <p:cNvSpPr txBox="1"/>
            <p:nvPr/>
          </p:nvSpPr>
          <p:spPr>
            <a:xfrm>
              <a:off x="4941405" y="1295400"/>
              <a:ext cx="5549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SE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6204910" y="2155985"/>
              <a:ext cx="19527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PhosphoNrf2 (S40</a:t>
              </a:r>
              <a:r>
                <a:rPr lang="en-US" dirty="0" smtClean="0"/>
                <a:t>)</a:t>
              </a:r>
              <a:endParaRPr lang="en-US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6233485" y="4176591"/>
              <a:ext cx="8691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GAPDH</a:t>
              </a:r>
              <a:endParaRPr lang="en-US" dirty="0"/>
            </a:p>
          </p:txBody>
        </p:sp>
        <p:sp>
          <p:nvSpPr>
            <p:cNvPr id="18" name="Rechteck 17"/>
            <p:cNvSpPr/>
            <p:nvPr/>
          </p:nvSpPr>
          <p:spPr>
            <a:xfrm>
              <a:off x="2474293" y="3072083"/>
              <a:ext cx="3726837" cy="4952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6204910" y="2636468"/>
              <a:ext cx="202972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PhosphoP38 MAPK</a:t>
              </a:r>
              <a:endParaRPr lang="en-US" dirty="0"/>
            </a:p>
          </p:txBody>
        </p:sp>
        <p:sp>
          <p:nvSpPr>
            <p:cNvPr id="29" name="Rechteck 28"/>
            <p:cNvSpPr/>
            <p:nvPr/>
          </p:nvSpPr>
          <p:spPr>
            <a:xfrm>
              <a:off x="2477249" y="3555323"/>
              <a:ext cx="3726837" cy="4952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hteck 29"/>
            <p:cNvSpPr/>
            <p:nvPr/>
          </p:nvSpPr>
          <p:spPr>
            <a:xfrm>
              <a:off x="2472555" y="4057648"/>
              <a:ext cx="3726837" cy="4952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6203787" y="3119938"/>
              <a:ext cx="77296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SOD-1</a:t>
              </a:r>
              <a:endParaRPr lang="en-US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6197350" y="3618306"/>
              <a:ext cx="970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Catalase</a:t>
              </a:r>
              <a:endParaRPr lang="en-US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641441" y="2155985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68 </a:t>
              </a:r>
              <a:r>
                <a:rPr lang="en-US" dirty="0"/>
                <a:t>k</a:t>
              </a:r>
              <a:r>
                <a:rPr lang="en-US" dirty="0" smtClean="0"/>
                <a:t>Da</a:t>
              </a:r>
              <a:endParaRPr lang="en-US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1621602" y="2639767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40 kDa</a:t>
              </a:r>
              <a:endParaRPr lang="en-US" dirty="0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1637541" y="3119938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23 kDa</a:t>
              </a:r>
              <a:endParaRPr lang="en-US" dirty="0"/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1631783" y="4120631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6 kDa</a:t>
              </a:r>
              <a:endParaRPr lang="en-US" dirty="0"/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1600200" y="3618306"/>
              <a:ext cx="82907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60 kDa</a:t>
              </a:r>
              <a:endParaRPr lang="en-US" dirty="0"/>
            </a:p>
          </p:txBody>
        </p:sp>
        <p:sp>
          <p:nvSpPr>
            <p:cNvPr id="44" name="Rechteck 43"/>
            <p:cNvSpPr/>
            <p:nvPr/>
          </p:nvSpPr>
          <p:spPr>
            <a:xfrm>
              <a:off x="2476950" y="4050622"/>
              <a:ext cx="3726837" cy="49529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7366871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Bildschirmpräsentation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orschung</dc:creator>
  <cp:lastModifiedBy>Forschung</cp:lastModifiedBy>
  <cp:revision>230</cp:revision>
  <cp:lastPrinted>2018-04-30T07:00:40Z</cp:lastPrinted>
  <dcterms:created xsi:type="dcterms:W3CDTF">2018-03-20T15:18:18Z</dcterms:created>
  <dcterms:modified xsi:type="dcterms:W3CDTF">2018-09-19T16:30:48Z</dcterms:modified>
</cp:coreProperties>
</file>